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2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3" d="100"/>
          <a:sy n="73" d="100"/>
        </p:scale>
        <p:origin x="325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im Hui Kheng" userId="20939611-dc46-461c-b286-1e84dc82e1a3" providerId="ADAL" clId="{8293CE4F-0C7F-43D4-96BC-FEB2E38F7AFD}"/>
    <pc:docChg chg="modSld">
      <pc:chgData name="Lim Hui Kheng" userId="20939611-dc46-461c-b286-1e84dc82e1a3" providerId="ADAL" clId="{8293CE4F-0C7F-43D4-96BC-FEB2E38F7AFD}" dt="2025-03-05T06:50:27.238" v="16" actId="1037"/>
      <pc:docMkLst>
        <pc:docMk/>
      </pc:docMkLst>
      <pc:sldChg chg="modSp mod">
        <pc:chgData name="Lim Hui Kheng" userId="20939611-dc46-461c-b286-1e84dc82e1a3" providerId="ADAL" clId="{8293CE4F-0C7F-43D4-96BC-FEB2E38F7AFD}" dt="2025-03-05T06:50:27.238" v="16" actId="1037"/>
        <pc:sldMkLst>
          <pc:docMk/>
          <pc:sldMk cId="1605861344" sldId="272"/>
        </pc:sldMkLst>
        <pc:spChg chg="mod">
          <ac:chgData name="Lim Hui Kheng" userId="20939611-dc46-461c-b286-1e84dc82e1a3" providerId="ADAL" clId="{8293CE4F-0C7F-43D4-96BC-FEB2E38F7AFD}" dt="2025-03-05T06:50:27.238" v="16" actId="1037"/>
          <ac:spMkLst>
            <pc:docMk/>
            <pc:sldMk cId="1605861344" sldId="272"/>
            <ac:spMk id="3" creationId="{8EC9FE94-8D65-6CB4-7E1E-9BBEE637882C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665B73-544B-48EF-A427-90FA71E88902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CEAD29-7DA2-4E4E-BBE5-FF10C99FBE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30513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A0F6DED-C42A-4DFF-8D5A-ADA28D99543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59496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2B415-F3B3-4479-AC50-01BBE5866A6A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DA14B-92F3-4287-8394-ED111375DE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67415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2B415-F3B3-4479-AC50-01BBE5866A6A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DA14B-92F3-4287-8394-ED111375DE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24897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2B415-F3B3-4479-AC50-01BBE5866A6A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DA14B-92F3-4287-8394-ED111375DE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82716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2B415-F3B3-4479-AC50-01BBE5866A6A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DA14B-92F3-4287-8394-ED111375DE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7478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2B415-F3B3-4479-AC50-01BBE5866A6A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DA14B-92F3-4287-8394-ED111375DE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06799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2B415-F3B3-4479-AC50-01BBE5866A6A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DA14B-92F3-4287-8394-ED111375DE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83529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2B415-F3B3-4479-AC50-01BBE5866A6A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DA14B-92F3-4287-8394-ED111375DE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63837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2B415-F3B3-4479-AC50-01BBE5866A6A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DA14B-92F3-4287-8394-ED111375DE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9603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2B415-F3B3-4479-AC50-01BBE5866A6A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DA14B-92F3-4287-8394-ED111375DE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9096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2B415-F3B3-4479-AC50-01BBE5866A6A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DA14B-92F3-4287-8394-ED111375DE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3197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2B415-F3B3-4479-AC50-01BBE5866A6A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DA14B-92F3-4287-8394-ED111375DE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2543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A72B415-F3B3-4479-AC50-01BBE5866A6A}" type="datetimeFigureOut">
              <a:rPr lang="en-US" smtClean="0"/>
              <a:t>3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5EDA14B-92F3-4287-8394-ED111375DE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96856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C1F5248C-25DC-8172-4F09-E43347FAB7F0}"/>
              </a:ext>
            </a:extLst>
          </p:cNvPr>
          <p:cNvGraphicFramePr>
            <a:graphicFrameLocks noGrp="1"/>
          </p:cNvGraphicFramePr>
          <p:nvPr/>
        </p:nvGraphicFramePr>
        <p:xfrm>
          <a:off x="471487" y="951707"/>
          <a:ext cx="5915025" cy="76965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995806">
                  <a:extLst>
                    <a:ext uri="{9D8B030D-6E8A-4147-A177-3AD203B41FA5}">
                      <a16:colId xmlns:a16="http://schemas.microsoft.com/office/drawing/2014/main" val="2577942682"/>
                    </a:ext>
                  </a:extLst>
                </a:gridCol>
                <a:gridCol w="584791">
                  <a:extLst>
                    <a:ext uri="{9D8B030D-6E8A-4147-A177-3AD203B41FA5}">
                      <a16:colId xmlns:a16="http://schemas.microsoft.com/office/drawing/2014/main" val="2654307171"/>
                    </a:ext>
                  </a:extLst>
                </a:gridCol>
                <a:gridCol w="574158">
                  <a:extLst>
                    <a:ext uri="{9D8B030D-6E8A-4147-A177-3AD203B41FA5}">
                      <a16:colId xmlns:a16="http://schemas.microsoft.com/office/drawing/2014/main" val="1596704006"/>
                    </a:ext>
                  </a:extLst>
                </a:gridCol>
                <a:gridCol w="651334">
                  <a:extLst>
                    <a:ext uri="{9D8B030D-6E8A-4147-A177-3AD203B41FA5}">
                      <a16:colId xmlns:a16="http://schemas.microsoft.com/office/drawing/2014/main" val="2463157380"/>
                    </a:ext>
                  </a:extLst>
                </a:gridCol>
                <a:gridCol w="635205">
                  <a:extLst>
                    <a:ext uri="{9D8B030D-6E8A-4147-A177-3AD203B41FA5}">
                      <a16:colId xmlns:a16="http://schemas.microsoft.com/office/drawing/2014/main" val="1509459675"/>
                    </a:ext>
                  </a:extLst>
                </a:gridCol>
                <a:gridCol w="637954">
                  <a:extLst>
                    <a:ext uri="{9D8B030D-6E8A-4147-A177-3AD203B41FA5}">
                      <a16:colId xmlns:a16="http://schemas.microsoft.com/office/drawing/2014/main" val="2453359538"/>
                    </a:ext>
                  </a:extLst>
                </a:gridCol>
                <a:gridCol w="648586">
                  <a:extLst>
                    <a:ext uri="{9D8B030D-6E8A-4147-A177-3AD203B41FA5}">
                      <a16:colId xmlns:a16="http://schemas.microsoft.com/office/drawing/2014/main" val="3336300801"/>
                    </a:ext>
                  </a:extLst>
                </a:gridCol>
                <a:gridCol w="584791">
                  <a:extLst>
                    <a:ext uri="{9D8B030D-6E8A-4147-A177-3AD203B41FA5}">
                      <a16:colId xmlns:a16="http://schemas.microsoft.com/office/drawing/2014/main" val="156384573"/>
                    </a:ext>
                  </a:extLst>
                </a:gridCol>
                <a:gridCol w="602400">
                  <a:extLst>
                    <a:ext uri="{9D8B030D-6E8A-4147-A177-3AD203B41FA5}">
                      <a16:colId xmlns:a16="http://schemas.microsoft.com/office/drawing/2014/main" val="4247783806"/>
                    </a:ext>
                  </a:extLst>
                </a:gridCol>
              </a:tblGrid>
              <a:tr h="118216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ENU (</a:t>
                      </a:r>
                      <a:r>
                        <a:rPr lang="el-GR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μ</a:t>
                      </a:r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g/ml)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MN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Buds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Mono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BN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CC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KR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PY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KL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7778628"/>
                  </a:ext>
                </a:extLst>
              </a:tr>
              <a:tr h="127114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DMSO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37 ± 0.1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88 ± 0.24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1.83 ± 0.89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35 ± 0.45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8 ± 0.04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3.83 ± 0.17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2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42 ± 0.21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933380965"/>
                  </a:ext>
                </a:extLst>
              </a:tr>
              <a:tr h="127114">
                <a:tc>
                  <a:txBody>
                    <a:bodyPr/>
                    <a:lstStyle/>
                    <a:p>
                      <a:pPr algn="ctr" fontAlgn="t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8.75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.40 ± 0.12*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80 ± 0.1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1.57 ± 0.6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87 ± 0.2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3.83 ± 0.3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20 ± 0.0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30 ± 0.1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/>
                </a:tc>
                <a:extLst>
                  <a:ext uri="{0D108BD9-81ED-4DB2-BD59-A6C34878D82A}">
                    <a16:rowId xmlns:a16="http://schemas.microsoft.com/office/drawing/2014/main" val="2541444998"/>
                  </a:ext>
                </a:extLst>
              </a:tr>
              <a:tr h="127114">
                <a:tc>
                  <a:txBody>
                    <a:bodyPr/>
                    <a:lstStyle/>
                    <a:p>
                      <a:pPr algn="ctr" fontAlgn="t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37.5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3.73 ± 0.22*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87 ± 0.19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88.40 ± 0.7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03 ± 0.3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0 ± 0.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5.43 ± 0.88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20 ± 0.1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33 ± 0.17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/>
                </a:tc>
                <a:extLst>
                  <a:ext uri="{0D108BD9-81ED-4DB2-BD59-A6C34878D82A}">
                    <a16:rowId xmlns:a16="http://schemas.microsoft.com/office/drawing/2014/main" val="3246762881"/>
                  </a:ext>
                </a:extLst>
              </a:tr>
              <a:tr h="127114">
                <a:tc>
                  <a:txBody>
                    <a:bodyPr/>
                    <a:lstStyle/>
                    <a:p>
                      <a:pPr algn="ctr" fontAlgn="t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7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4.73 ± 0.35*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30 ± 0.12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86.30 ± 0.36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13 ± 0.03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27 ± 0.07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5.57 ± 0.39*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47 ± 0.12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23 ± 0.09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/>
                </a:tc>
                <a:extLst>
                  <a:ext uri="{0D108BD9-81ED-4DB2-BD59-A6C34878D82A}">
                    <a16:rowId xmlns:a16="http://schemas.microsoft.com/office/drawing/2014/main" val="4138510584"/>
                  </a:ext>
                </a:extLst>
              </a:tr>
              <a:tr h="127114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5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4.13 ± 0.22*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33 ± 0.18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88.00 ± 1.3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33 ± 0.3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3 ± 0.013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4.43 ± 0.9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53 ± 0.03*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0 ± 0.00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356" marR="6356" marT="6356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5948344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A0A34BAB-4447-B6AF-03F7-3C2FBA3F7A80}"/>
              </a:ext>
            </a:extLst>
          </p:cNvPr>
          <p:cNvGraphicFramePr>
            <a:graphicFrameLocks noGrp="1"/>
          </p:cNvGraphicFramePr>
          <p:nvPr/>
        </p:nvGraphicFramePr>
        <p:xfrm>
          <a:off x="471486" y="1808972"/>
          <a:ext cx="5915026" cy="774122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995807">
                  <a:extLst>
                    <a:ext uri="{9D8B030D-6E8A-4147-A177-3AD203B41FA5}">
                      <a16:colId xmlns:a16="http://schemas.microsoft.com/office/drawing/2014/main" val="2366611068"/>
                    </a:ext>
                  </a:extLst>
                </a:gridCol>
                <a:gridCol w="574158">
                  <a:extLst>
                    <a:ext uri="{9D8B030D-6E8A-4147-A177-3AD203B41FA5}">
                      <a16:colId xmlns:a16="http://schemas.microsoft.com/office/drawing/2014/main" val="3565237318"/>
                    </a:ext>
                  </a:extLst>
                </a:gridCol>
                <a:gridCol w="584791">
                  <a:extLst>
                    <a:ext uri="{9D8B030D-6E8A-4147-A177-3AD203B41FA5}">
                      <a16:colId xmlns:a16="http://schemas.microsoft.com/office/drawing/2014/main" val="2800823225"/>
                    </a:ext>
                  </a:extLst>
                </a:gridCol>
                <a:gridCol w="659218">
                  <a:extLst>
                    <a:ext uri="{9D8B030D-6E8A-4147-A177-3AD203B41FA5}">
                      <a16:colId xmlns:a16="http://schemas.microsoft.com/office/drawing/2014/main" val="4173806233"/>
                    </a:ext>
                  </a:extLst>
                </a:gridCol>
                <a:gridCol w="637954">
                  <a:extLst>
                    <a:ext uri="{9D8B030D-6E8A-4147-A177-3AD203B41FA5}">
                      <a16:colId xmlns:a16="http://schemas.microsoft.com/office/drawing/2014/main" val="4093647005"/>
                    </a:ext>
                  </a:extLst>
                </a:gridCol>
                <a:gridCol w="637953">
                  <a:extLst>
                    <a:ext uri="{9D8B030D-6E8A-4147-A177-3AD203B41FA5}">
                      <a16:colId xmlns:a16="http://schemas.microsoft.com/office/drawing/2014/main" val="3609692103"/>
                    </a:ext>
                  </a:extLst>
                </a:gridCol>
                <a:gridCol w="637954">
                  <a:extLst>
                    <a:ext uri="{9D8B030D-6E8A-4147-A177-3AD203B41FA5}">
                      <a16:colId xmlns:a16="http://schemas.microsoft.com/office/drawing/2014/main" val="3272227070"/>
                    </a:ext>
                  </a:extLst>
                </a:gridCol>
                <a:gridCol w="595423">
                  <a:extLst>
                    <a:ext uri="{9D8B030D-6E8A-4147-A177-3AD203B41FA5}">
                      <a16:colId xmlns:a16="http://schemas.microsoft.com/office/drawing/2014/main" val="921163504"/>
                    </a:ext>
                  </a:extLst>
                </a:gridCol>
                <a:gridCol w="591768">
                  <a:extLst>
                    <a:ext uri="{9D8B030D-6E8A-4147-A177-3AD203B41FA5}">
                      <a16:colId xmlns:a16="http://schemas.microsoft.com/office/drawing/2014/main" val="3182556794"/>
                    </a:ext>
                  </a:extLst>
                </a:gridCol>
              </a:tblGrid>
              <a:tr h="120109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GA (</a:t>
                      </a:r>
                      <a:r>
                        <a:rPr lang="el-GR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μ</a:t>
                      </a:r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g/ml)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MN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Buds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Mono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BN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CC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KR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PY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KL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73004168"/>
                  </a:ext>
                </a:extLst>
              </a:tr>
              <a:tr h="129149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H2O 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53 ± 0.1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55 ± 0.1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3.70 ± 0.78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97 ± 0.0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3 ± 0.0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.72 ± 0.5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25 ± 0.0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5 ± 0.1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873796144"/>
                  </a:ext>
                </a:extLst>
              </a:tr>
              <a:tr h="129149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.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.00 ± 0.4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83 ± 0.24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2.40 ± 1.7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87 ± 0.24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3.50 ± 1.1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20 ± 0.1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7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/>
                </a:tc>
                <a:extLst>
                  <a:ext uri="{0D108BD9-81ED-4DB2-BD59-A6C34878D82A}">
                    <a16:rowId xmlns:a16="http://schemas.microsoft.com/office/drawing/2014/main" val="120097276"/>
                  </a:ext>
                </a:extLst>
              </a:tr>
              <a:tr h="129149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5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.97 ± 0.13*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20 ± 0.06*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89.03 ± 1.3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13 ± 0.24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0 ± 0.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4.87 ± 0.9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43 ± 0.28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37 ± 0.1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/>
                </a:tc>
                <a:extLst>
                  <a:ext uri="{0D108BD9-81ED-4DB2-BD59-A6C34878D82A}">
                    <a16:rowId xmlns:a16="http://schemas.microsoft.com/office/drawing/2014/main" val="2971469329"/>
                  </a:ext>
                </a:extLst>
              </a:tr>
              <a:tr h="129149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3.56 ± 0.7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30 ± 0.3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88.31 ± 1.5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03 ± 0.2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7 ± 0.0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4.93 ± 0.85*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47 ± 0.18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33 ± 0.1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/>
                </a:tc>
                <a:extLst>
                  <a:ext uri="{0D108BD9-81ED-4DB2-BD59-A6C34878D82A}">
                    <a16:rowId xmlns:a16="http://schemas.microsoft.com/office/drawing/2014/main" val="2542602170"/>
                  </a:ext>
                </a:extLst>
              </a:tr>
              <a:tr h="129149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3.70 ± 0.32*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13 ± 0.38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89.36 ± 0.34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07 ± 0.24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3 ± 0.0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4.03 ± 0.3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50 ± 0.3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7 ± 0.09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a:txBody>
                  <a:tcPr marL="6457" marR="6457" marT="6457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1948990"/>
                  </a:ext>
                </a:extLst>
              </a:tr>
            </a:tbl>
          </a:graphicData>
        </a:graphic>
      </p:graphicFrame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674635DA-DB31-D8F0-1CFD-A63A8C81A546}"/>
              </a:ext>
            </a:extLst>
          </p:cNvPr>
          <p:cNvGraphicFramePr>
            <a:graphicFrameLocks noGrp="1"/>
          </p:cNvGraphicFramePr>
          <p:nvPr/>
        </p:nvGraphicFramePr>
        <p:xfrm>
          <a:off x="471488" y="2669293"/>
          <a:ext cx="5915025" cy="77794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995805">
                  <a:extLst>
                    <a:ext uri="{9D8B030D-6E8A-4147-A177-3AD203B41FA5}">
                      <a16:colId xmlns:a16="http://schemas.microsoft.com/office/drawing/2014/main" val="3304734997"/>
                    </a:ext>
                  </a:extLst>
                </a:gridCol>
                <a:gridCol w="580814">
                  <a:extLst>
                    <a:ext uri="{9D8B030D-6E8A-4147-A177-3AD203B41FA5}">
                      <a16:colId xmlns:a16="http://schemas.microsoft.com/office/drawing/2014/main" val="3910755076"/>
                    </a:ext>
                  </a:extLst>
                </a:gridCol>
                <a:gridCol w="578135">
                  <a:extLst>
                    <a:ext uri="{9D8B030D-6E8A-4147-A177-3AD203B41FA5}">
                      <a16:colId xmlns:a16="http://schemas.microsoft.com/office/drawing/2014/main" val="1435393524"/>
                    </a:ext>
                  </a:extLst>
                </a:gridCol>
                <a:gridCol w="659218">
                  <a:extLst>
                    <a:ext uri="{9D8B030D-6E8A-4147-A177-3AD203B41FA5}">
                      <a16:colId xmlns:a16="http://schemas.microsoft.com/office/drawing/2014/main" val="3150244517"/>
                    </a:ext>
                  </a:extLst>
                </a:gridCol>
                <a:gridCol w="637954">
                  <a:extLst>
                    <a:ext uri="{9D8B030D-6E8A-4147-A177-3AD203B41FA5}">
                      <a16:colId xmlns:a16="http://schemas.microsoft.com/office/drawing/2014/main" val="3018352843"/>
                    </a:ext>
                  </a:extLst>
                </a:gridCol>
                <a:gridCol w="648586">
                  <a:extLst>
                    <a:ext uri="{9D8B030D-6E8A-4147-A177-3AD203B41FA5}">
                      <a16:colId xmlns:a16="http://schemas.microsoft.com/office/drawing/2014/main" val="919210239"/>
                    </a:ext>
                  </a:extLst>
                </a:gridCol>
                <a:gridCol w="627321">
                  <a:extLst>
                    <a:ext uri="{9D8B030D-6E8A-4147-A177-3AD203B41FA5}">
                      <a16:colId xmlns:a16="http://schemas.microsoft.com/office/drawing/2014/main" val="1920423351"/>
                    </a:ext>
                  </a:extLst>
                </a:gridCol>
                <a:gridCol w="595423">
                  <a:extLst>
                    <a:ext uri="{9D8B030D-6E8A-4147-A177-3AD203B41FA5}">
                      <a16:colId xmlns:a16="http://schemas.microsoft.com/office/drawing/2014/main" val="4059028844"/>
                    </a:ext>
                  </a:extLst>
                </a:gridCol>
                <a:gridCol w="591769">
                  <a:extLst>
                    <a:ext uri="{9D8B030D-6E8A-4147-A177-3AD203B41FA5}">
                      <a16:colId xmlns:a16="http://schemas.microsoft.com/office/drawing/2014/main" val="147338461"/>
                    </a:ext>
                  </a:extLst>
                </a:gridCol>
              </a:tblGrid>
              <a:tr h="120812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Paclitaxel (</a:t>
                      </a:r>
                      <a:r>
                        <a:rPr lang="el-GR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μ</a:t>
                      </a:r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g/ml)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MN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Buds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Mono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BN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CC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KR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PY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KL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2390085"/>
                  </a:ext>
                </a:extLst>
              </a:tr>
              <a:tr h="129905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% DMSO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33 ± 0.2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58 ± 0.4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4.35 ± 1.88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90 ± 0.2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.37 ± 0.92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0 ± 0.06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33 ± 0.15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881451079"/>
                  </a:ext>
                </a:extLst>
              </a:tr>
              <a:tr h="129905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75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73 ± 0.5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50 ± 0.21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2.97 ± 1.9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0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0 ± 0.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3.50 ± 1.0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7 ± 0.0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0 ± 0.0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/>
                </a:tc>
                <a:extLst>
                  <a:ext uri="{0D108BD9-81ED-4DB2-BD59-A6C34878D82A}">
                    <a16:rowId xmlns:a16="http://schemas.microsoft.com/office/drawing/2014/main" val="3356835141"/>
                  </a:ext>
                </a:extLst>
              </a:tr>
              <a:tr h="129905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5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.10 ± 0.1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77 ± 0.2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0.60 ± 2.0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9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0 ± 0.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5.20 ± 1.7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7 ± 0.0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23 ± 0.1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/>
                </a:tc>
                <a:extLst>
                  <a:ext uri="{0D108BD9-81ED-4DB2-BD59-A6C34878D82A}">
                    <a16:rowId xmlns:a16="http://schemas.microsoft.com/office/drawing/2014/main" val="3979031506"/>
                  </a:ext>
                </a:extLst>
              </a:tr>
              <a:tr h="129905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3.27 ± 0.20**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93 ± 0.3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88.17 ± 1.84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43 ± 0.3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5.43 ± 1.54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37 ± 0.09*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37 ± 0.0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/>
                </a:tc>
                <a:extLst>
                  <a:ext uri="{0D108BD9-81ED-4DB2-BD59-A6C34878D82A}">
                    <a16:rowId xmlns:a16="http://schemas.microsoft.com/office/drawing/2014/main" val="2742470233"/>
                  </a:ext>
                </a:extLst>
              </a:tr>
              <a:tr h="129905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6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3.63 ± 0.27**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03 ± 0.2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88.17 ± 1.6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37 ± 0.54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0 ± 0.1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4.97 ± 0.7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40 ± 0.1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33 ± 0.12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495" marR="6495" marT="649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0019977"/>
                  </a:ext>
                </a:extLst>
              </a:tr>
            </a:tbl>
          </a:graphicData>
        </a:graphic>
      </p:graphicFrame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03472AF6-2C12-2A4C-B1EB-69D360FCADE5}"/>
              </a:ext>
            </a:extLst>
          </p:cNvPr>
          <p:cNvGraphicFramePr>
            <a:graphicFrameLocks noGrp="1"/>
          </p:cNvGraphicFramePr>
          <p:nvPr/>
        </p:nvGraphicFramePr>
        <p:xfrm>
          <a:off x="471488" y="3532550"/>
          <a:ext cx="5915025" cy="765954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985172">
                  <a:extLst>
                    <a:ext uri="{9D8B030D-6E8A-4147-A177-3AD203B41FA5}">
                      <a16:colId xmlns:a16="http://schemas.microsoft.com/office/drawing/2014/main" val="1516437551"/>
                    </a:ext>
                  </a:extLst>
                </a:gridCol>
                <a:gridCol w="584791">
                  <a:extLst>
                    <a:ext uri="{9D8B030D-6E8A-4147-A177-3AD203B41FA5}">
                      <a16:colId xmlns:a16="http://schemas.microsoft.com/office/drawing/2014/main" val="814889236"/>
                    </a:ext>
                  </a:extLst>
                </a:gridCol>
                <a:gridCol w="595423">
                  <a:extLst>
                    <a:ext uri="{9D8B030D-6E8A-4147-A177-3AD203B41FA5}">
                      <a16:colId xmlns:a16="http://schemas.microsoft.com/office/drawing/2014/main" val="146552460"/>
                    </a:ext>
                  </a:extLst>
                </a:gridCol>
                <a:gridCol w="659219">
                  <a:extLst>
                    <a:ext uri="{9D8B030D-6E8A-4147-A177-3AD203B41FA5}">
                      <a16:colId xmlns:a16="http://schemas.microsoft.com/office/drawing/2014/main" val="205024803"/>
                    </a:ext>
                  </a:extLst>
                </a:gridCol>
                <a:gridCol w="627321">
                  <a:extLst>
                    <a:ext uri="{9D8B030D-6E8A-4147-A177-3AD203B41FA5}">
                      <a16:colId xmlns:a16="http://schemas.microsoft.com/office/drawing/2014/main" val="2421745938"/>
                    </a:ext>
                  </a:extLst>
                </a:gridCol>
                <a:gridCol w="648586">
                  <a:extLst>
                    <a:ext uri="{9D8B030D-6E8A-4147-A177-3AD203B41FA5}">
                      <a16:colId xmlns:a16="http://schemas.microsoft.com/office/drawing/2014/main" val="2123275729"/>
                    </a:ext>
                  </a:extLst>
                </a:gridCol>
                <a:gridCol w="627321">
                  <a:extLst>
                    <a:ext uri="{9D8B030D-6E8A-4147-A177-3AD203B41FA5}">
                      <a16:colId xmlns:a16="http://schemas.microsoft.com/office/drawing/2014/main" val="2804622502"/>
                    </a:ext>
                  </a:extLst>
                </a:gridCol>
                <a:gridCol w="595423">
                  <a:extLst>
                    <a:ext uri="{9D8B030D-6E8A-4147-A177-3AD203B41FA5}">
                      <a16:colId xmlns:a16="http://schemas.microsoft.com/office/drawing/2014/main" val="2069382522"/>
                    </a:ext>
                  </a:extLst>
                </a:gridCol>
                <a:gridCol w="591769">
                  <a:extLst>
                    <a:ext uri="{9D8B030D-6E8A-4147-A177-3AD203B41FA5}">
                      <a16:colId xmlns:a16="http://schemas.microsoft.com/office/drawing/2014/main" val="1904934606"/>
                    </a:ext>
                  </a:extLst>
                </a:gridCol>
              </a:tblGrid>
              <a:tr h="106746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AFB1 (</a:t>
                      </a:r>
                      <a:r>
                        <a:rPr lang="el-GR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μ</a:t>
                      </a:r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g/ml)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MN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Buds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Mono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BN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CC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KR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PY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KL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9589106"/>
                  </a:ext>
                </a:extLst>
              </a:tr>
              <a:tr h="114781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% DMSO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33 ± 0.12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40 ± 0.21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3.17 ± 0.72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60 ± 0.1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4.20 ± 0.2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23 ± 0.07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4035559462"/>
                  </a:ext>
                </a:extLst>
              </a:tr>
              <a:tr h="114781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.77 ± 0.4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33 ± 0.0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1.03 ± 1.21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63 ± 0.1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4.80 ± 0.7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37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extLst>
                  <a:ext uri="{0D108BD9-81ED-4DB2-BD59-A6C34878D82A}">
                    <a16:rowId xmlns:a16="http://schemas.microsoft.com/office/drawing/2014/main" val="3284005496"/>
                  </a:ext>
                </a:extLst>
              </a:tr>
              <a:tr h="114781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3.10 ± 0.5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43 ± 0.0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0.77 ± 0.6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77 ± 0.2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0 ± 0.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4.57 ± 0.3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33 ± 0.1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extLst>
                  <a:ext uri="{0D108BD9-81ED-4DB2-BD59-A6C34878D82A}">
                    <a16:rowId xmlns:a16="http://schemas.microsoft.com/office/drawing/2014/main" val="346720506"/>
                  </a:ext>
                </a:extLst>
              </a:tr>
              <a:tr h="114781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4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3.67 ± 0.58*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60 ± 0.21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89.73 ± 1.3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77 ± 0.2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0 ± 0.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4.70 ± 0.2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7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47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extLst>
                  <a:ext uri="{0D108BD9-81ED-4DB2-BD59-A6C34878D82A}">
                    <a16:rowId xmlns:a16="http://schemas.microsoft.com/office/drawing/2014/main" val="2615583150"/>
                  </a:ext>
                </a:extLst>
              </a:tr>
              <a:tr h="114781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6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4.20 ± 0.46*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40 ± 0.1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89.50 ± 0.8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97 ± 0.3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7 ± 0.0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4.03 ± 0.1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7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77 ± 0.12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2986802"/>
                  </a:ext>
                </a:extLst>
              </a:tr>
            </a:tbl>
          </a:graphicData>
        </a:graphic>
      </p:graphicFrame>
      <p:graphicFrame>
        <p:nvGraphicFramePr>
          <p:cNvPr id="14" name="Table 13">
            <a:extLst>
              <a:ext uri="{FF2B5EF4-FFF2-40B4-BE49-F238E27FC236}">
                <a16:creationId xmlns:a16="http://schemas.microsoft.com/office/drawing/2014/main" id="{4D7A0421-ECE9-6176-170F-20504D26BC9F}"/>
              </a:ext>
            </a:extLst>
          </p:cNvPr>
          <p:cNvGraphicFramePr>
            <a:graphicFrameLocks noGrp="1"/>
          </p:cNvGraphicFramePr>
          <p:nvPr/>
        </p:nvGraphicFramePr>
        <p:xfrm>
          <a:off x="471488" y="4385813"/>
          <a:ext cx="5915025" cy="769548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985172">
                  <a:extLst>
                    <a:ext uri="{9D8B030D-6E8A-4147-A177-3AD203B41FA5}">
                      <a16:colId xmlns:a16="http://schemas.microsoft.com/office/drawing/2014/main" val="1792817623"/>
                    </a:ext>
                  </a:extLst>
                </a:gridCol>
                <a:gridCol w="584791">
                  <a:extLst>
                    <a:ext uri="{9D8B030D-6E8A-4147-A177-3AD203B41FA5}">
                      <a16:colId xmlns:a16="http://schemas.microsoft.com/office/drawing/2014/main" val="4160238493"/>
                    </a:ext>
                  </a:extLst>
                </a:gridCol>
                <a:gridCol w="595423">
                  <a:extLst>
                    <a:ext uri="{9D8B030D-6E8A-4147-A177-3AD203B41FA5}">
                      <a16:colId xmlns:a16="http://schemas.microsoft.com/office/drawing/2014/main" val="1562673844"/>
                    </a:ext>
                  </a:extLst>
                </a:gridCol>
                <a:gridCol w="669852">
                  <a:extLst>
                    <a:ext uri="{9D8B030D-6E8A-4147-A177-3AD203B41FA5}">
                      <a16:colId xmlns:a16="http://schemas.microsoft.com/office/drawing/2014/main" val="880128132"/>
                    </a:ext>
                  </a:extLst>
                </a:gridCol>
                <a:gridCol w="627321">
                  <a:extLst>
                    <a:ext uri="{9D8B030D-6E8A-4147-A177-3AD203B41FA5}">
                      <a16:colId xmlns:a16="http://schemas.microsoft.com/office/drawing/2014/main" val="386348430"/>
                    </a:ext>
                  </a:extLst>
                </a:gridCol>
                <a:gridCol w="637953">
                  <a:extLst>
                    <a:ext uri="{9D8B030D-6E8A-4147-A177-3AD203B41FA5}">
                      <a16:colId xmlns:a16="http://schemas.microsoft.com/office/drawing/2014/main" val="2965743357"/>
                    </a:ext>
                  </a:extLst>
                </a:gridCol>
                <a:gridCol w="627321">
                  <a:extLst>
                    <a:ext uri="{9D8B030D-6E8A-4147-A177-3AD203B41FA5}">
                      <a16:colId xmlns:a16="http://schemas.microsoft.com/office/drawing/2014/main" val="3852300505"/>
                    </a:ext>
                  </a:extLst>
                </a:gridCol>
                <a:gridCol w="606056">
                  <a:extLst>
                    <a:ext uri="{9D8B030D-6E8A-4147-A177-3AD203B41FA5}">
                      <a16:colId xmlns:a16="http://schemas.microsoft.com/office/drawing/2014/main" val="2553514766"/>
                    </a:ext>
                  </a:extLst>
                </a:gridCol>
                <a:gridCol w="581136">
                  <a:extLst>
                    <a:ext uri="{9D8B030D-6E8A-4147-A177-3AD203B41FA5}">
                      <a16:colId xmlns:a16="http://schemas.microsoft.com/office/drawing/2014/main" val="3511616524"/>
                    </a:ext>
                  </a:extLst>
                </a:gridCol>
              </a:tblGrid>
              <a:tr h="117878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EMS (</a:t>
                      </a:r>
                      <a:r>
                        <a:rPr lang="el-GR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μ</a:t>
                      </a:r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g/ml)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MN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Buds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Mono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BN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CC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KR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PY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KL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0106031"/>
                  </a:ext>
                </a:extLst>
              </a:tr>
              <a:tr h="126751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% DMSO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53 ± 0.0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80 ± 0.2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2.43 ± 0.48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77 ± 0.1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7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3.93 ± 0.5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7 ± 0.1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30 ± 0.0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582840452"/>
                  </a:ext>
                </a:extLst>
              </a:tr>
              <a:tr h="126751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31.5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.17 ± 0.3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47 ± 0.2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2.50 ± 1.3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73 ± 0.24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3.73 ± 0.4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3 ± 0.1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23 ± 0.1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extLst>
                  <a:ext uri="{0D108BD9-81ED-4DB2-BD59-A6C34878D82A}">
                    <a16:rowId xmlns:a16="http://schemas.microsoft.com/office/drawing/2014/main" val="1420181266"/>
                  </a:ext>
                </a:extLst>
              </a:tr>
              <a:tr h="126751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62.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.90 ± 0.26*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57 ± 0.2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2.67 ± 0.6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43 ± 0.0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3.07 ± 0.4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0 ± 0.0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23 ± 0.1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extLst>
                  <a:ext uri="{0D108BD9-81ED-4DB2-BD59-A6C34878D82A}">
                    <a16:rowId xmlns:a16="http://schemas.microsoft.com/office/drawing/2014/main" val="3367913953"/>
                  </a:ext>
                </a:extLst>
              </a:tr>
              <a:tr h="126751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25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3.50 ± 0.26**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83 ± 0.0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0.23 ± 0.6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83 ± 0.41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7 ± 0.0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4.03 ± 0.9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37 ± 0.2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/>
                </a:tc>
                <a:extLst>
                  <a:ext uri="{0D108BD9-81ED-4DB2-BD59-A6C34878D82A}">
                    <a16:rowId xmlns:a16="http://schemas.microsoft.com/office/drawing/2014/main" val="1911574006"/>
                  </a:ext>
                </a:extLst>
              </a:tr>
              <a:tr h="126751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50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4.20 ± 0.27**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00 ± 0.21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89.47 ± 1.1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90 ± 0.40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3.67 ± 0.5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20 ± 0.1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53 ± 0.17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38" marR="6338" marT="633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8921601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8EC9FE94-8D65-6CB4-7E1E-9BBEE637882C}"/>
              </a:ext>
            </a:extLst>
          </p:cNvPr>
          <p:cNvSpPr txBox="1"/>
          <p:nvPr/>
        </p:nvSpPr>
        <p:spPr>
          <a:xfrm>
            <a:off x="191042" y="696777"/>
            <a:ext cx="6640830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SG" sz="1000" dirty="0">
                <a:effectLst/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table 1</a:t>
            </a:r>
            <a:r>
              <a:rPr lang="en-US" sz="1000" dirty="0">
                <a:latin typeface="Arial Narrow" panose="020B0606020202030204" pitchFamily="34" charset="0"/>
              </a:rPr>
              <a:t>: Cell phenotype and nuclear anomalies of known genotoxins tested in </a:t>
            </a:r>
            <a:r>
              <a:rPr lang="en-SG" sz="1000" dirty="0">
                <a:latin typeface="Arial Narrow" panose="020B0606020202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ICyt assay</a:t>
            </a:r>
            <a:r>
              <a:rPr lang="en-US" sz="1000" dirty="0">
                <a:latin typeface="Arial Narrow" panose="020B0606020202030204" pitchFamily="34" charset="0"/>
              </a:rPr>
              <a:t> with 3D </a:t>
            </a:r>
            <a:r>
              <a:rPr lang="en-US" sz="1000" dirty="0" err="1">
                <a:latin typeface="Arial Narrow" panose="020B0606020202030204" pitchFamily="34" charset="0"/>
              </a:rPr>
              <a:t>EpiIntestinal</a:t>
            </a:r>
            <a:r>
              <a:rPr lang="en-US" sz="1000" dirty="0">
                <a:latin typeface="Arial Narrow" panose="020B0606020202030204" pitchFamily="34" charset="0"/>
              </a:rPr>
              <a:t>™ microtissu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715BF17-453C-7A95-F7DA-D335BAF3E59B}"/>
              </a:ext>
            </a:extLst>
          </p:cNvPr>
          <p:cNvSpPr txBox="1"/>
          <p:nvPr/>
        </p:nvSpPr>
        <p:spPr>
          <a:xfrm>
            <a:off x="400050" y="6043334"/>
            <a:ext cx="5986462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b="0" dirty="0">
                <a:latin typeface="Arial Narrow" panose="020B0606020202030204" pitchFamily="34" charset="0"/>
              </a:rPr>
              <a:t>ENU, N-ethyl-N-nitrosourea; </a:t>
            </a:r>
            <a:r>
              <a:rPr lang="en-SG" sz="1000" dirty="0">
                <a:latin typeface="Arial Narrow" panose="020B0606020202030204" pitchFamily="34" charset="0"/>
              </a:rPr>
              <a:t>GA, </a:t>
            </a:r>
            <a:r>
              <a:rPr lang="en-SG" sz="1000" dirty="0" err="1">
                <a:latin typeface="Arial Narrow" panose="020B0606020202030204" pitchFamily="34" charset="0"/>
              </a:rPr>
              <a:t>Glycidamide</a:t>
            </a:r>
            <a:r>
              <a:rPr lang="en-SG" sz="1000" dirty="0">
                <a:latin typeface="Arial Narrow" panose="020B0606020202030204" pitchFamily="34" charset="0"/>
              </a:rPr>
              <a:t>; AFB1, Aflatoxin B1; EMS, Ethyl </a:t>
            </a:r>
            <a:r>
              <a:rPr lang="en-SG" sz="1000" dirty="0" err="1">
                <a:latin typeface="Arial Narrow" panose="020B0606020202030204" pitchFamily="34" charset="0"/>
              </a:rPr>
              <a:t>methanesulfonate</a:t>
            </a:r>
            <a:r>
              <a:rPr lang="en-SG" sz="1000" dirty="0">
                <a:latin typeface="Arial Narrow" panose="020B0606020202030204" pitchFamily="34" charset="0"/>
              </a:rPr>
              <a:t>; </a:t>
            </a:r>
            <a:r>
              <a:rPr lang="en-US" sz="1000" dirty="0">
                <a:latin typeface="Arial Narrow" panose="020B0606020202030204" pitchFamily="34" charset="0"/>
              </a:rPr>
              <a:t>MN, micronuclei; Buds, nuclear buds, Mono, mononucleated cells (basal and differentiated); BN, binucleated cells; CC, condensed chromatin; KR, karyorrhexis; PY, pyknosis; KL, </a:t>
            </a:r>
            <a:r>
              <a:rPr lang="en-US" sz="1000" dirty="0" err="1">
                <a:latin typeface="Arial Narrow" panose="020B0606020202030204" pitchFamily="34" charset="0"/>
              </a:rPr>
              <a:t>karyolysis</a:t>
            </a:r>
            <a:r>
              <a:rPr lang="en-US" sz="1000" dirty="0">
                <a:latin typeface="Arial Narrow" panose="020B0606020202030204" pitchFamily="34" charset="0"/>
              </a:rPr>
              <a:t>; </a:t>
            </a:r>
            <a:endParaRPr lang="en-SG" sz="1000" b="0" i="0" u="none" strike="noStrike" dirty="0">
              <a:solidFill>
                <a:srgbClr val="000000"/>
              </a:solidFill>
              <a:effectLst/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8D45D41A-4DA2-7263-C638-615E5E39C64F}"/>
              </a:ext>
            </a:extLst>
          </p:cNvPr>
          <p:cNvGraphicFramePr>
            <a:graphicFrameLocks noGrp="1"/>
          </p:cNvGraphicFramePr>
          <p:nvPr/>
        </p:nvGraphicFramePr>
        <p:xfrm>
          <a:off x="471486" y="5237817"/>
          <a:ext cx="5915026" cy="771143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968015">
                  <a:extLst>
                    <a:ext uri="{9D8B030D-6E8A-4147-A177-3AD203B41FA5}">
                      <a16:colId xmlns:a16="http://schemas.microsoft.com/office/drawing/2014/main" val="2903978874"/>
                    </a:ext>
                  </a:extLst>
                </a:gridCol>
                <a:gridCol w="579422">
                  <a:extLst>
                    <a:ext uri="{9D8B030D-6E8A-4147-A177-3AD203B41FA5}">
                      <a16:colId xmlns:a16="http://schemas.microsoft.com/office/drawing/2014/main" val="2568667107"/>
                    </a:ext>
                  </a:extLst>
                </a:gridCol>
                <a:gridCol w="606582">
                  <a:extLst>
                    <a:ext uri="{9D8B030D-6E8A-4147-A177-3AD203B41FA5}">
                      <a16:colId xmlns:a16="http://schemas.microsoft.com/office/drawing/2014/main" val="1308916422"/>
                    </a:ext>
                  </a:extLst>
                </a:gridCol>
                <a:gridCol w="688063">
                  <a:extLst>
                    <a:ext uri="{9D8B030D-6E8A-4147-A177-3AD203B41FA5}">
                      <a16:colId xmlns:a16="http://schemas.microsoft.com/office/drawing/2014/main" val="1257098673"/>
                    </a:ext>
                  </a:extLst>
                </a:gridCol>
                <a:gridCol w="615636">
                  <a:extLst>
                    <a:ext uri="{9D8B030D-6E8A-4147-A177-3AD203B41FA5}">
                      <a16:colId xmlns:a16="http://schemas.microsoft.com/office/drawing/2014/main" val="2689465319"/>
                    </a:ext>
                  </a:extLst>
                </a:gridCol>
                <a:gridCol w="651849">
                  <a:extLst>
                    <a:ext uri="{9D8B030D-6E8A-4147-A177-3AD203B41FA5}">
                      <a16:colId xmlns:a16="http://schemas.microsoft.com/office/drawing/2014/main" val="3610853672"/>
                    </a:ext>
                  </a:extLst>
                </a:gridCol>
                <a:gridCol w="624690">
                  <a:extLst>
                    <a:ext uri="{9D8B030D-6E8A-4147-A177-3AD203B41FA5}">
                      <a16:colId xmlns:a16="http://schemas.microsoft.com/office/drawing/2014/main" val="2484439650"/>
                    </a:ext>
                  </a:extLst>
                </a:gridCol>
                <a:gridCol w="597528">
                  <a:extLst>
                    <a:ext uri="{9D8B030D-6E8A-4147-A177-3AD203B41FA5}">
                      <a16:colId xmlns:a16="http://schemas.microsoft.com/office/drawing/2014/main" val="3853257584"/>
                    </a:ext>
                  </a:extLst>
                </a:gridCol>
                <a:gridCol w="583241">
                  <a:extLst>
                    <a:ext uri="{9D8B030D-6E8A-4147-A177-3AD203B41FA5}">
                      <a16:colId xmlns:a16="http://schemas.microsoft.com/office/drawing/2014/main" val="131267094"/>
                    </a:ext>
                  </a:extLst>
                </a:gridCol>
              </a:tblGrid>
              <a:tr h="115567">
                <a:tc>
                  <a:txBody>
                    <a:bodyPr/>
                    <a:lstStyle/>
                    <a:p>
                      <a:pPr algn="ctr" fontAlgn="ctr"/>
                      <a:r>
                        <a:rPr lang="el-GR" sz="800" b="0" u="none" strike="noStrike" dirty="0">
                          <a:effectLst/>
                          <a:latin typeface="Arial Narrow" panose="020B0606020202030204" pitchFamily="34" charset="0"/>
                        </a:rPr>
                        <a:t>β-</a:t>
                      </a:r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asarone (µg/ml)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MN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Buds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Mono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BN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CC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KR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PY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KL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3854615"/>
                  </a:ext>
                </a:extLst>
              </a:tr>
              <a:tr h="124265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1% DMSO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1.25 ± 0.15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37 ± 0.12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95.08 ± 0.53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53 ± 0.14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10 ± 0.06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2.55 ± 0.48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00 ± 0.00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12 ± 0.04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369363317"/>
                  </a:ext>
                </a:extLst>
              </a:tr>
              <a:tr h="124265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10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1.13 ± 0.1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50 ± 0.15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94.43 ± 0.19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77 ± 0.0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00 ± 0.00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3.10 ± 0.25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00 ± 0.00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07 ± 0.07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/>
                </a:tc>
                <a:extLst>
                  <a:ext uri="{0D108BD9-81ED-4DB2-BD59-A6C34878D82A}">
                    <a16:rowId xmlns:a16="http://schemas.microsoft.com/office/drawing/2014/main" val="2029429980"/>
                  </a:ext>
                </a:extLst>
              </a:tr>
              <a:tr h="124265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25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1.24 ± 0.14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50 ± 0.1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93.87 ± 0.6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91 ± 0.12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07 ± 0.03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3.31 ± 0.6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00 ± 0.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10 ± 0.00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/>
                </a:tc>
                <a:extLst>
                  <a:ext uri="{0D108BD9-81ED-4DB2-BD59-A6C34878D82A}">
                    <a16:rowId xmlns:a16="http://schemas.microsoft.com/office/drawing/2014/main" val="2734612055"/>
                  </a:ext>
                </a:extLst>
              </a:tr>
              <a:tr h="124265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5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1.50 ± 0.1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43 ± 0.0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91.80 ± 0.2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1.00 ± 0.2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4.93 ± 0.78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17 ± 0.07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13 ± 0.1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/>
                </a:tc>
                <a:extLst>
                  <a:ext uri="{0D108BD9-81ED-4DB2-BD59-A6C34878D82A}">
                    <a16:rowId xmlns:a16="http://schemas.microsoft.com/office/drawing/2014/main" val="4188729996"/>
                  </a:ext>
                </a:extLst>
              </a:tr>
              <a:tr h="130478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1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1.40 ± 0.3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30 ± 0.0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92.83 ± 0.1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67 ± 0.18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10 ± 0.0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4.50 ± 0.7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07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13 ± 0.13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213" marR="6213" marT="621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736587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058613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46</Words>
  <Application>Microsoft Office PowerPoint</Application>
  <PresentationFormat>A4 Paper (210x297 mm)</PresentationFormat>
  <Paragraphs>32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Arial Narrow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im Hui Kheng</dc:creator>
  <cp:lastModifiedBy>Lim Hui Kheng</cp:lastModifiedBy>
  <cp:revision>1</cp:revision>
  <dcterms:created xsi:type="dcterms:W3CDTF">2025-01-27T06:16:18Z</dcterms:created>
  <dcterms:modified xsi:type="dcterms:W3CDTF">2025-03-05T06:50:30Z</dcterms:modified>
</cp:coreProperties>
</file>